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65"/>
  </p:normalViewPr>
  <p:slideViewPr>
    <p:cSldViewPr snapToGrid="0">
      <p:cViewPr varScale="1">
        <p:scale>
          <a:sx n="89" d="100"/>
          <a:sy n="89" d="100"/>
        </p:scale>
        <p:origin x="89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omividossa/Documents/SCIPUB/benagen-contract/ms%20preparation/D.zingiberensis-amylose/R1/CV_erro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33808710974065"/>
          <c:y val="3.0562502148657349E-2"/>
          <c:w val="0.85043114365949013"/>
          <c:h val="0.76953126894904866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numRef>
              <c:f>CV_error!$G$3:$G$11</c:f>
              <c:numCache>
                <c:formatCode>General</c:formatCode>
                <c:ptCount val="9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</c:numCache>
            </c:numRef>
          </c:cat>
          <c:val>
            <c:numRef>
              <c:f>CV_error!$H$3:$H$11</c:f>
              <c:numCache>
                <c:formatCode>General</c:formatCode>
                <c:ptCount val="9"/>
                <c:pt idx="0">
                  <c:v>0.30486000000000002</c:v>
                </c:pt>
                <c:pt idx="1">
                  <c:v>0.27911000000000002</c:v>
                </c:pt>
                <c:pt idx="2">
                  <c:v>0.31567000000000001</c:v>
                </c:pt>
                <c:pt idx="3">
                  <c:v>0.32462000000000002</c:v>
                </c:pt>
                <c:pt idx="4">
                  <c:v>0.33528000000000002</c:v>
                </c:pt>
                <c:pt idx="5">
                  <c:v>0.34861999999999999</c:v>
                </c:pt>
                <c:pt idx="6">
                  <c:v>0.36421999999999999</c:v>
                </c:pt>
                <c:pt idx="7">
                  <c:v>0.38846999999999998</c:v>
                </c:pt>
                <c:pt idx="8">
                  <c:v>0.420219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1D6-F841-B773-3D9BB8D7DF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82101695"/>
        <c:axId val="1481711967"/>
      </c:lineChart>
      <c:catAx>
        <c:axId val="148210169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200"/>
                  <a:t>K</a:t>
                </a:r>
              </a:p>
            </c:rich>
          </c:tx>
          <c:layout>
            <c:manualLayout>
              <c:xMode val="edge"/>
              <c:yMode val="edge"/>
              <c:x val="0.4801733109410275"/>
              <c:y val="0.8830936363254806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481711967"/>
        <c:crosses val="autoZero"/>
        <c:auto val="1"/>
        <c:lblAlgn val="ctr"/>
        <c:lblOffset val="100"/>
        <c:noMultiLvlLbl val="0"/>
      </c:catAx>
      <c:valAx>
        <c:axId val="1481711967"/>
        <c:scaling>
          <c:orientation val="minMax"/>
          <c:min val="0.2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600"/>
                  <a:t>CV error</a:t>
                </a:r>
              </a:p>
            </c:rich>
          </c:tx>
          <c:layout>
            <c:manualLayout>
              <c:xMode val="edge"/>
              <c:yMode val="edge"/>
              <c:x val="1.2237762237762238E-2"/>
              <c:y val="0.3556160261259860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4821016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63F97C5-0B6F-F3F2-11CF-AC9F8708E2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578251B-BF88-5553-654A-A650D294FC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86B5452-87FD-1D93-4C01-F0C65A69A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F179A1F-438D-E3D9-7667-E929D6B59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31A83D1-DFD5-1C08-F896-56674AEB8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2115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0EBB34-DD3B-125E-3F39-20B78DA6A1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6A3CE44-E8A0-3177-D35D-C9768C0B8E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506FC7F-C6A3-2434-D4DB-B16693251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62CDD1E-E98A-1645-9E2C-A9A69EF26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22F0812-290C-FF48-B3EC-98A8D2393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0133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E9EEF1BD-4D48-CF6D-DCFD-E33117BD8C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768ACBF-4D38-7FE0-5255-AE3CB82702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2B9B9E8-15AA-8E9F-71D0-DEDD24785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B13467D-7952-B6F9-2BC1-CC326C29A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6392445-5C6F-DCCE-6C83-2B71F354C8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7693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D41B32-FE41-81A4-8496-29475048DA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CCC85D8-D35D-0E47-535E-6B71F82F0D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615E83C-6F72-8488-C90A-F0A27B6AC1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4965233-599C-24E7-244E-B9F394AFB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293B8F-7F13-4A04-2A8E-4E7A511A09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3718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31C9889-F0FB-5F10-22C7-9E19E7E5FB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93768A9-0CBD-4437-7D8D-98BA145973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3301E5C-53C0-37AD-AB40-E7D23E72F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D304F80-A914-EA4C-419C-4E1DC07AC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0B33DBD-477A-6E8E-9314-42DECD637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9186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705280D-F222-F2A1-EA72-F1484866AF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D768177-5C11-A399-8F5A-8C899B5E01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BDB64E1-8A6E-2860-4D1C-BCC6772E86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2E9A1E3-DB6C-8F59-B7B6-590961F09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B6E89A9-980A-0812-3CD2-80C54446C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02081CD-056F-1654-0E7C-63C9EDB223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6312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4DE5E9A-B169-FD82-587E-867D63C14C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9271BA5-A179-1E2C-8790-EA5716272A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4D3612B-8956-8566-F0D5-641CD47308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F3E0C86E-4423-CAED-A930-00F0BC2788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38FD214-C375-5C90-FA38-F78F0900B4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203EEC6-0CB1-D703-9A8F-56706DE25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4507E57-7EB6-0EFD-C3E5-0260C8C70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84F2784-51F0-01DC-FE88-71F692CD3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5852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C9FDFC1-C678-1329-05F3-9A0C5470EC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45AD0B7-50B5-7DAA-8F8F-E70A887AA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1C2A040F-0A7F-D28D-23C2-080295C8F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A652925-BFFF-93E3-017E-10F8EEB254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0538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10B3D542-F87A-5F66-51C6-92B6F4F9E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AC379522-C6DA-AA19-CC25-EF51917116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E4F3F2D-8B72-50D5-BDA7-D93615DCC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3097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05EE9A-662D-C1B2-1ABF-F0E71F55CD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55448B2-63C4-D4A8-BCE6-3062DF1007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27300C0-95C2-CFFA-1FB3-84E7ACD854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C8DB964-2B8A-530E-2673-52396EA3AE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62F6DDE-ADB4-0052-5EF0-39196EF52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293B4EB-1C1F-08C2-DA59-E1CA5B40D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0264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79A26B3-97C2-2F2F-55AC-F020583E68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B666936-AA20-C247-AAE7-6F909DE486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01C8EF8-ED07-AB36-23FE-B1B21EB771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D9E676D-4D2C-9CFF-DB5E-F7B62EAF3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0F5D56B-37C1-EB21-4F03-9F8EBF971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C54940F-D54A-98E9-2D9F-444B9E9C7B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9637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9C6A652-3E3E-6A27-B005-368FBA747E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8E18310-0237-197C-BDEE-6EFF4F7E80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FF217EA-745D-B930-1519-D565ED05AF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E041F-88E2-0D49-810E-1BE0E07B4B89}" type="datetimeFigureOut">
              <a:rPr lang="fr-FR" smtClean="0"/>
              <a:t>03/03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1F5B948-C4F8-0578-DE67-4553E8C404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26E776-B2C9-B92D-FA4E-22E817FD34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8E01AD-0E2F-8240-A108-F3099E17AD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481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C07F5692-DAEF-5C00-302E-C413D496B8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9139209"/>
              </p:ext>
            </p:extLst>
          </p:nvPr>
        </p:nvGraphicFramePr>
        <p:xfrm>
          <a:off x="2895600" y="541867"/>
          <a:ext cx="7264400" cy="47413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ZoneTexte 5">
            <a:extLst>
              <a:ext uri="{FF2B5EF4-FFF2-40B4-BE49-F238E27FC236}">
                <a16:creationId xmlns:a16="http://schemas.microsoft.com/office/drawing/2014/main" id="{C9C18971-B5DB-EEEA-DB71-1EF838355DA7}"/>
              </a:ext>
            </a:extLst>
          </p:cNvPr>
          <p:cNvSpPr txBox="1"/>
          <p:nvPr/>
        </p:nvSpPr>
        <p:spPr>
          <a:xfrm>
            <a:off x="2671763" y="5500688"/>
            <a:ext cx="838676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/>
              <a:t>Supplementary</a:t>
            </a:r>
            <a:r>
              <a:rPr lang="fr-FR" b="1" dirty="0"/>
              <a:t> </a:t>
            </a:r>
            <a:r>
              <a:rPr lang="fr-FR" b="1"/>
              <a:t>Figure 1</a:t>
            </a:r>
            <a:r>
              <a:rPr lang="fr-FR"/>
              <a:t>: 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Plot of ADMIXTURE cross validation (CV) error from K=2 to K=10 in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Dioscorea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zingiberensis</a:t>
            </a:r>
            <a:r>
              <a:rPr lang="en-US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 diversity panel. We selected K=3 as the value that minimizes the error.</a:t>
            </a:r>
            <a:endParaRPr lang="fr-FR" sz="18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48998270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43</Words>
  <Application>Microsoft Macintosh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office</dc:creator>
  <cp:lastModifiedBy>office</cp:lastModifiedBy>
  <cp:revision>2</cp:revision>
  <dcterms:created xsi:type="dcterms:W3CDTF">2024-02-25T19:47:09Z</dcterms:created>
  <dcterms:modified xsi:type="dcterms:W3CDTF">2024-03-03T17:25:52Z</dcterms:modified>
</cp:coreProperties>
</file>